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32" r:id="rId1"/>
  </p:sldMasterIdLst>
  <p:notesMasterIdLst>
    <p:notesMasterId r:id="rId3"/>
  </p:notesMasterIdLst>
  <p:sldIdLst>
    <p:sldId id="271" r:id="rId2"/>
  </p:sldIdLst>
  <p:sldSz cx="9144000" cy="5715000" type="screen16x1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345E965-0140-ADE0-DB2C-DDC75760A289}" name="Alessandro Fatatis" initials="AF" userId="S::af39@drexel.edu::5421c82d-accb-43d6-bc52-f8c7455fa968" providerId="AD"/>
  <p188:author id="{0D443DB4-5F58-0368-B600-A387FC99D53C}" name="Dinatale,Anthony" initials="D" userId="S::acd84@drexel.edu::4c6ef405-d2be-481c-925d-4add091459f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FC"/>
    <a:srgbClr val="2125FF"/>
    <a:srgbClr val="00B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011"/>
    <p:restoredTop sz="96327"/>
  </p:normalViewPr>
  <p:slideViewPr>
    <p:cSldViewPr snapToGrid="0" snapToObjects="1">
      <p:cViewPr varScale="1">
        <p:scale>
          <a:sx n="148" d="100"/>
          <a:sy n="148" d="100"/>
        </p:scale>
        <p:origin x="704" y="192"/>
      </p:cViewPr>
      <p:guideLst/>
    </p:cSldViewPr>
  </p:slideViewPr>
  <p:notesTextViewPr>
    <p:cViewPr>
      <p:scale>
        <a:sx n="114" d="100"/>
        <a:sy n="114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2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9FFED5-8238-1442-BCC4-7B81FEB7EF0C}" type="datetimeFigureOut">
              <a:rPr lang="en-US" smtClean="0"/>
              <a:t>11/2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720975" y="857250"/>
            <a:ext cx="370205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518B98-75F2-1243-9ECC-791F8B5F4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8854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1pPr>
    <a:lvl2pPr marL="408127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2pPr>
    <a:lvl3pPr marL="816254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3pPr>
    <a:lvl4pPr marL="1224380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4pPr>
    <a:lvl5pPr marL="1632507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5pPr>
    <a:lvl6pPr marL="2040634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6pPr>
    <a:lvl7pPr marL="2448761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7pPr>
    <a:lvl8pPr marL="2856889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8pPr>
    <a:lvl9pPr marL="3265014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720975" y="857250"/>
            <a:ext cx="3702050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591124-4521-724D-8BFA-E3EDB7838D8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7956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935302"/>
            <a:ext cx="6858000" cy="19896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001698"/>
            <a:ext cx="6858000" cy="137980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727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168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04271"/>
            <a:ext cx="1971675" cy="484319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04271"/>
            <a:ext cx="5800725" cy="484319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149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4723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424782"/>
            <a:ext cx="7886700" cy="2377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824553"/>
            <a:ext cx="7886700" cy="125015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869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521354"/>
            <a:ext cx="3886200" cy="36261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521354"/>
            <a:ext cx="3886200" cy="36261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905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04271"/>
            <a:ext cx="7886700" cy="110463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400969"/>
            <a:ext cx="3868340" cy="68659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087563"/>
            <a:ext cx="3868340" cy="30704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400969"/>
            <a:ext cx="3887391" cy="68659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087563"/>
            <a:ext cx="3887391" cy="30704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0790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656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4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81000"/>
            <a:ext cx="2949178" cy="13335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822855"/>
            <a:ext cx="4629150" cy="4061354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714500"/>
            <a:ext cx="2949178" cy="317632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488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81000"/>
            <a:ext cx="2949178" cy="13335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822855"/>
            <a:ext cx="4629150" cy="4061354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714500"/>
            <a:ext cx="2949178" cy="317632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302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04271"/>
            <a:ext cx="7886700" cy="11046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521354"/>
            <a:ext cx="7886700" cy="362611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5296959"/>
            <a:ext cx="20574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5296959"/>
            <a:ext cx="30861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5296959"/>
            <a:ext cx="20574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476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D782F3C-C488-D54C-92A3-B30E83A32E9F}"/>
              </a:ext>
            </a:extLst>
          </p:cNvPr>
          <p:cNvSpPr txBox="1"/>
          <p:nvPr/>
        </p:nvSpPr>
        <p:spPr>
          <a:xfrm>
            <a:off x="735853" y="4788189"/>
            <a:ext cx="767229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C3-ML cells show no difference in luciferase activity between the wild-type promoter and 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AR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L-1β promoter, in which the ARE half-site located at -576 was removed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8714934-63D7-F746-9FFD-89FAEFE03E6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0388"/>
          <a:stretch/>
        </p:blipFill>
        <p:spPr>
          <a:xfrm>
            <a:off x="2369458" y="711367"/>
            <a:ext cx="4405084" cy="279383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B35B7C7-4816-1298-B245-D6095EA1F46E}"/>
              </a:ext>
            </a:extLst>
          </p:cNvPr>
          <p:cNvSpPr txBox="1"/>
          <p:nvPr/>
        </p:nvSpPr>
        <p:spPr>
          <a:xfrm rot="18600000">
            <a:off x="3196272" y="3283269"/>
            <a:ext cx="1024127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n-US" sz="1400" b="1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omoter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ild-Typ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C3150CE-07D1-FE12-369E-7AE6981DA0AB}"/>
              </a:ext>
            </a:extLst>
          </p:cNvPr>
          <p:cNvSpPr txBox="1"/>
          <p:nvPr/>
        </p:nvSpPr>
        <p:spPr>
          <a:xfrm rot="18600000">
            <a:off x="4080518" y="3299037"/>
            <a:ext cx="982961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n-US" sz="1400" b="1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omoter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RE𝚫</a:t>
            </a:r>
          </a:p>
        </p:txBody>
      </p:sp>
    </p:spTree>
    <p:extLst>
      <p:ext uri="{BB962C8B-B14F-4D97-AF65-F5344CB8AC3E}">
        <p14:creationId xmlns:p14="http://schemas.microsoft.com/office/powerpoint/2010/main" val="19886253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054</TotalTime>
  <Words>43</Words>
  <Application>Microsoft Macintosh PowerPoint</Application>
  <PresentationFormat>On-screen Show (16:10)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ssandro Fatatis</dc:creator>
  <cp:lastModifiedBy>Alessandro Fatatis</cp:lastModifiedBy>
  <cp:revision>255</cp:revision>
  <dcterms:created xsi:type="dcterms:W3CDTF">2021-08-27T21:58:33Z</dcterms:created>
  <dcterms:modified xsi:type="dcterms:W3CDTF">2022-11-02T10:44:19Z</dcterms:modified>
</cp:coreProperties>
</file>